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50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66" y="1268760"/>
            <a:ext cx="8862814" cy="38799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938612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596" y="1124744"/>
            <a:ext cx="9051404" cy="38733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12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10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7584391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1412776"/>
            <a:ext cx="8364091" cy="35810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12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1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787590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1268760"/>
            <a:ext cx="8345041" cy="3696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12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1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4646080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56" y="1340768"/>
            <a:ext cx="9118079" cy="3942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12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1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51587917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5536" y="1556792"/>
            <a:ext cx="8129017" cy="35886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12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1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2973510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1052736"/>
            <a:ext cx="8598141" cy="38164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122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1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51371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340768"/>
            <a:ext cx="8032626" cy="3365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679564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1720782"/>
            <a:ext cx="7365504" cy="2707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753410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753" y="1700808"/>
            <a:ext cx="8726247" cy="3737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4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813289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484784"/>
            <a:ext cx="8733656" cy="37170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819554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1196752"/>
            <a:ext cx="8762108" cy="38884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6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5068296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575" y="1556792"/>
            <a:ext cx="8196833" cy="33328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7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589260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569" y="1268760"/>
            <a:ext cx="8930630" cy="35935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8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503117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268760"/>
            <a:ext cx="8570590" cy="37807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79512" y="54868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ZjCNGC9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06845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15</Words>
  <Application>Microsoft Office PowerPoint</Application>
  <PresentationFormat>全屏显示(4:3)</PresentationFormat>
  <Paragraphs>15</Paragraphs>
  <Slides>1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5</vt:i4>
      </vt:variant>
    </vt:vector>
  </HeadingPairs>
  <TitlesOfParts>
    <vt:vector size="16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LXWJT</dc:creator>
  <cp:lastModifiedBy>WLXWJT</cp:lastModifiedBy>
  <cp:revision>5</cp:revision>
  <dcterms:created xsi:type="dcterms:W3CDTF">2019-03-28T03:26:36Z</dcterms:created>
  <dcterms:modified xsi:type="dcterms:W3CDTF">2019-03-28T06:23:10Z</dcterms:modified>
</cp:coreProperties>
</file>